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79" r:id="rId2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CC00"/>
    <a:srgbClr val="CDAFC9"/>
    <a:srgbClr val="FF99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1410" y="-4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CA69D7E-9461-4C2D-962D-1CAA5A562E25}" type="datetimeFigureOut">
              <a:rPr lang="en-US" smtClean="0"/>
              <a:t>6/19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53F800-1904-47B8-B42B-298DEA27F10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775602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58F88B7-E3F6-49A0-BC14-3A55FA7D3C0C}" type="datetimeFigureOut">
              <a:rPr lang="en-US" smtClean="0"/>
              <a:t>6/19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81100" y="696913"/>
            <a:ext cx="4648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16425"/>
            <a:ext cx="5607050" cy="418306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513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46E2C34-4AD9-45E3-A7DF-ADB9F89239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0050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5C825-57BC-4454-B11C-CBC4280A63F3}" type="datetimeFigureOut">
              <a:rPr lang="en-US" smtClean="0"/>
              <a:t>6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E4696-CAF5-45BA-B6E0-C7EB370A51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62565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5C825-57BC-4454-B11C-CBC4280A63F3}" type="datetimeFigureOut">
              <a:rPr lang="en-US" smtClean="0"/>
              <a:t>6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E4696-CAF5-45BA-B6E0-C7EB370A51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80251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5C825-57BC-4454-B11C-CBC4280A63F3}" type="datetimeFigureOut">
              <a:rPr lang="en-US" smtClean="0"/>
              <a:t>6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E4696-CAF5-45BA-B6E0-C7EB370A51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34764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5C825-57BC-4454-B11C-CBC4280A63F3}" type="datetimeFigureOut">
              <a:rPr lang="en-US" smtClean="0"/>
              <a:t>6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E4696-CAF5-45BA-B6E0-C7EB370A51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76942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5C825-57BC-4454-B11C-CBC4280A63F3}" type="datetimeFigureOut">
              <a:rPr lang="en-US" smtClean="0"/>
              <a:t>6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E4696-CAF5-45BA-B6E0-C7EB370A51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28211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5C825-57BC-4454-B11C-CBC4280A63F3}" type="datetimeFigureOut">
              <a:rPr lang="en-US" smtClean="0"/>
              <a:t>6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E4696-CAF5-45BA-B6E0-C7EB370A51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73338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5C825-57BC-4454-B11C-CBC4280A63F3}" type="datetimeFigureOut">
              <a:rPr lang="en-US" smtClean="0"/>
              <a:t>6/19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E4696-CAF5-45BA-B6E0-C7EB370A51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04035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5C825-57BC-4454-B11C-CBC4280A63F3}" type="datetimeFigureOut">
              <a:rPr lang="en-US" smtClean="0"/>
              <a:t>6/19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E4696-CAF5-45BA-B6E0-C7EB370A51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12428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5C825-57BC-4454-B11C-CBC4280A63F3}" type="datetimeFigureOut">
              <a:rPr lang="en-US" smtClean="0"/>
              <a:t>6/19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E4696-CAF5-45BA-B6E0-C7EB370A51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45842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5C825-57BC-4454-B11C-CBC4280A63F3}" type="datetimeFigureOut">
              <a:rPr lang="en-US" smtClean="0"/>
              <a:t>6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E4696-CAF5-45BA-B6E0-C7EB370A51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91791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25C825-57BC-4454-B11C-CBC4280A63F3}" type="datetimeFigureOut">
              <a:rPr lang="en-US" smtClean="0"/>
              <a:t>6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E4696-CAF5-45BA-B6E0-C7EB370A51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47287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25C825-57BC-4454-B11C-CBC4280A63F3}" type="datetimeFigureOut">
              <a:rPr lang="en-US" smtClean="0"/>
              <a:t>6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AE4696-CAF5-45BA-B6E0-C7EB370A517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08962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/>
          <p:cNvGrpSpPr/>
          <p:nvPr/>
        </p:nvGrpSpPr>
        <p:grpSpPr>
          <a:xfrm>
            <a:off x="585216" y="335729"/>
            <a:ext cx="8122041" cy="6028578"/>
            <a:chOff x="585216" y="335729"/>
            <a:chExt cx="8122041" cy="6028578"/>
          </a:xfrm>
        </p:grpSpPr>
        <p:sp>
          <p:nvSpPr>
            <p:cNvPr id="15" name="TextBox 17"/>
            <p:cNvSpPr txBox="1">
              <a:spLocks noChangeArrowheads="1"/>
            </p:cNvSpPr>
            <p:nvPr/>
          </p:nvSpPr>
          <p:spPr bwMode="auto">
            <a:xfrm>
              <a:off x="1776115" y="723533"/>
              <a:ext cx="5336126" cy="4001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r>
                <a:rPr lang="en-US" sz="2000" b="1" dirty="0" smtClean="0"/>
                <a:t>Baseline CD27 expression level in </a:t>
              </a:r>
              <a:r>
                <a:rPr lang="en-US" sz="2000" b="1" dirty="0" smtClean="0"/>
                <a:t>T </a:t>
              </a:r>
              <a:r>
                <a:rPr lang="en-US" sz="2000" b="1" dirty="0" smtClean="0"/>
                <a:t>cell subsets</a:t>
              </a:r>
              <a:endParaRPr lang="en-US" sz="2000" b="1" dirty="0"/>
            </a:p>
          </p:txBody>
        </p:sp>
        <p:grpSp>
          <p:nvGrpSpPr>
            <p:cNvPr id="6" name="Group 5"/>
            <p:cNvGrpSpPr/>
            <p:nvPr/>
          </p:nvGrpSpPr>
          <p:grpSpPr>
            <a:xfrm>
              <a:off x="585216" y="1403818"/>
              <a:ext cx="8122041" cy="3768114"/>
              <a:chOff x="585216" y="2163818"/>
              <a:chExt cx="8122041" cy="3768114"/>
            </a:xfrm>
          </p:grpSpPr>
          <p:sp>
            <p:nvSpPr>
              <p:cNvPr id="3" name="TextBox 2"/>
              <p:cNvSpPr txBox="1"/>
              <p:nvPr/>
            </p:nvSpPr>
            <p:spPr>
              <a:xfrm>
                <a:off x="585216" y="3605784"/>
                <a:ext cx="95891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Donor A</a:t>
                </a:r>
                <a:endParaRPr lang="en-US" dirty="0"/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615696" y="4861568"/>
                <a:ext cx="950901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Donor B</a:t>
                </a:r>
                <a:endParaRPr lang="en-US" dirty="0"/>
              </a:p>
            </p:txBody>
          </p:sp>
          <p:grpSp>
            <p:nvGrpSpPr>
              <p:cNvPr id="2" name="Group 1"/>
              <p:cNvGrpSpPr/>
              <p:nvPr/>
            </p:nvGrpSpPr>
            <p:grpSpPr>
              <a:xfrm>
                <a:off x="1808062" y="2163818"/>
                <a:ext cx="4904573" cy="749594"/>
                <a:chOff x="1808062" y="1906643"/>
                <a:chExt cx="4904573" cy="749594"/>
              </a:xfrm>
            </p:grpSpPr>
            <p:sp>
              <p:nvSpPr>
                <p:cNvPr id="21" name="TextBox 20"/>
                <p:cNvSpPr txBox="1"/>
                <p:nvPr/>
              </p:nvSpPr>
              <p:spPr>
                <a:xfrm>
                  <a:off x="2515291" y="1911477"/>
                  <a:ext cx="56778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 smtClean="0"/>
                    <a:t>CD4</a:t>
                  </a:r>
                  <a:endParaRPr lang="en-US" dirty="0"/>
                </a:p>
              </p:txBody>
            </p:sp>
            <p:sp>
              <p:nvSpPr>
                <p:cNvPr id="23" name="TextBox 22"/>
                <p:cNvSpPr txBox="1"/>
                <p:nvPr/>
              </p:nvSpPr>
              <p:spPr>
                <a:xfrm>
                  <a:off x="5220652" y="1906643"/>
                  <a:ext cx="567784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 smtClean="0"/>
                    <a:t>CD8</a:t>
                  </a:r>
                  <a:endParaRPr lang="en-US" dirty="0"/>
                </a:p>
              </p:txBody>
            </p:sp>
            <p:sp>
              <p:nvSpPr>
                <p:cNvPr id="22" name="TextBox 21"/>
                <p:cNvSpPr txBox="1"/>
                <p:nvPr/>
              </p:nvSpPr>
              <p:spPr>
                <a:xfrm>
                  <a:off x="1808062" y="2280809"/>
                  <a:ext cx="942887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 smtClean="0"/>
                    <a:t>CD45RA</a:t>
                  </a:r>
                  <a:endParaRPr lang="en-US" dirty="0"/>
                </a:p>
              </p:txBody>
            </p:sp>
            <p:sp>
              <p:nvSpPr>
                <p:cNvPr id="25" name="TextBox 24"/>
                <p:cNvSpPr txBox="1"/>
                <p:nvPr/>
              </p:nvSpPr>
              <p:spPr>
                <a:xfrm>
                  <a:off x="3081745" y="2286905"/>
                  <a:ext cx="959878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 smtClean="0"/>
                    <a:t>CD45RO</a:t>
                  </a:r>
                  <a:endParaRPr lang="en-US" dirty="0"/>
                </a:p>
              </p:txBody>
            </p:sp>
            <p:sp>
              <p:nvSpPr>
                <p:cNvPr id="26" name="TextBox 25"/>
                <p:cNvSpPr txBox="1"/>
                <p:nvPr/>
              </p:nvSpPr>
              <p:spPr>
                <a:xfrm>
                  <a:off x="4539451" y="2274713"/>
                  <a:ext cx="942887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 smtClean="0"/>
                    <a:t>CD45RA</a:t>
                  </a:r>
                  <a:endParaRPr lang="en-US" dirty="0"/>
                </a:p>
              </p:txBody>
            </p:sp>
            <p:sp>
              <p:nvSpPr>
                <p:cNvPr id="27" name="TextBox 26"/>
                <p:cNvSpPr txBox="1"/>
                <p:nvPr/>
              </p:nvSpPr>
              <p:spPr>
                <a:xfrm>
                  <a:off x="5594059" y="2280809"/>
                  <a:ext cx="1118576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 smtClean="0"/>
                    <a:t>   CD45RO</a:t>
                  </a:r>
                  <a:endParaRPr lang="en-US" dirty="0"/>
                </a:p>
              </p:txBody>
            </p:sp>
            <p:cxnSp>
              <p:nvCxnSpPr>
                <p:cNvPr id="28" name="Straight Connector 27"/>
                <p:cNvCxnSpPr/>
                <p:nvPr/>
              </p:nvCxnSpPr>
              <p:spPr>
                <a:xfrm>
                  <a:off x="1808062" y="2274713"/>
                  <a:ext cx="2014486" cy="0"/>
                </a:xfrm>
                <a:prstGeom prst="line">
                  <a:avLst/>
                </a:prstGeom>
                <a:ln w="285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30" name="Straight Connector 29"/>
                <p:cNvCxnSpPr/>
                <p:nvPr/>
              </p:nvCxnSpPr>
              <p:spPr>
                <a:xfrm>
                  <a:off x="4563835" y="2268617"/>
                  <a:ext cx="2014486" cy="0"/>
                </a:xfrm>
                <a:prstGeom prst="line">
                  <a:avLst/>
                </a:prstGeom>
                <a:ln w="28575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1" name="TextBox 30"/>
              <p:cNvSpPr txBox="1"/>
              <p:nvPr/>
            </p:nvSpPr>
            <p:spPr>
              <a:xfrm>
                <a:off x="7124388" y="2317409"/>
                <a:ext cx="1582869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dirty="0" smtClean="0"/>
                  <a:t>CD4</a:t>
                </a:r>
                <a:r>
                  <a:rPr lang="en-US" baseline="30000" dirty="0" smtClean="0"/>
                  <a:t>+</a:t>
                </a:r>
              </a:p>
              <a:p>
                <a:r>
                  <a:rPr lang="en-US" dirty="0" smtClean="0"/>
                  <a:t>CD25hi FoxP3</a:t>
                </a:r>
                <a:r>
                  <a:rPr lang="en-US" baseline="30000" dirty="0" smtClean="0"/>
                  <a:t>+</a:t>
                </a:r>
                <a:endParaRPr lang="en-US" baseline="30000" dirty="0"/>
              </a:p>
            </p:txBody>
          </p:sp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547559" y="2895600"/>
                <a:ext cx="7159698" cy="2667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24" name="TextBox 23"/>
              <p:cNvSpPr txBox="1"/>
              <p:nvPr/>
            </p:nvSpPr>
            <p:spPr>
              <a:xfrm>
                <a:off x="1594702" y="5562600"/>
                <a:ext cx="684803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/>
                  <a:t>CD27</a:t>
                </a:r>
                <a:endParaRPr lang="en-US" dirty="0"/>
              </a:p>
            </p:txBody>
          </p:sp>
          <p:cxnSp>
            <p:nvCxnSpPr>
              <p:cNvPr id="7" name="Straight Arrow Connector 6"/>
              <p:cNvCxnSpPr>
                <a:stCxn id="24" idx="3"/>
              </p:cNvCxnSpPr>
              <p:nvPr/>
            </p:nvCxnSpPr>
            <p:spPr>
              <a:xfrm>
                <a:off x="2279505" y="5747266"/>
                <a:ext cx="6254895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" name="TextBox 3"/>
            <p:cNvSpPr txBox="1"/>
            <p:nvPr/>
          </p:nvSpPr>
          <p:spPr>
            <a:xfrm>
              <a:off x="972447" y="5410200"/>
              <a:ext cx="7734810" cy="95410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/>
                <a:t>Pan T cells were isolated from normal donor PBMCs using Miltenyi magnetic  bead isolation kit and stained for naïve, memory and Treg phenotypic markers. Cells were stained for subset-specific markers and CD27. Shaded histograms are stained with isotype-matched IgG controls. Numbers above the bar denote percentage of cells positive for CD27; numbers below refer to MFI values.</a:t>
              </a:r>
              <a:endParaRPr lang="en-US" sz="1400" dirty="0"/>
            </a:p>
          </p:txBody>
        </p:sp>
        <p:sp>
          <p:nvSpPr>
            <p:cNvPr id="32" name="TextBox 2899"/>
            <p:cNvSpPr txBox="1"/>
            <p:nvPr/>
          </p:nvSpPr>
          <p:spPr>
            <a:xfrm>
              <a:off x="3797916" y="335729"/>
              <a:ext cx="139653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 smtClean="0"/>
                <a:t>Additional File </a:t>
              </a:r>
              <a:r>
                <a:rPr lang="en-US" sz="1400" b="1" dirty="0" smtClean="0"/>
                <a:t>3</a:t>
              </a:r>
              <a:endParaRPr lang="en-US" sz="14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8352263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49</TotalTime>
  <Words>91</Words>
  <Application>Microsoft Office PowerPoint</Application>
  <PresentationFormat>On-screen Show (4:3)</PresentationFormat>
  <Paragraphs>1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enky Ramakrishna</dc:creator>
  <cp:lastModifiedBy>Venky Ramakrishna</cp:lastModifiedBy>
  <cp:revision>127</cp:revision>
  <cp:lastPrinted>2014-12-10T15:48:53Z</cp:lastPrinted>
  <dcterms:created xsi:type="dcterms:W3CDTF">2014-08-29T14:19:17Z</dcterms:created>
  <dcterms:modified xsi:type="dcterms:W3CDTF">2015-06-19T13:38:54Z</dcterms:modified>
</cp:coreProperties>
</file>